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A2183-B484-469E-8F2D-9B3A04175D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7D685-DAF0-497E-A628-1BA1AAEB2C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66B5A-599B-4F4A-8E8F-BCF35FA981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E8923-60F8-4412-9E52-BEBF522582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97DE9-9987-4D01-88EF-AE91D08A7E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36740-5989-4723-A8EF-6A5414DCE0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0D57A-65B5-49B7-94B6-1794B4756F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A6357-584B-40F4-8D57-40BCFA2B9E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F2217-13CA-4DF8-92EA-088BB910CB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37712-A541-4036-9618-72DEABBDED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096A4-EA0D-4F81-8C17-586DA024BD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07D8E-A740-4E67-B920-01B2E5691E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09CD1A-7BD2-4513-A914-94509CAA314C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26"/>
          <p:cNvGrpSpPr/>
          <p:nvPr/>
        </p:nvGrpSpPr>
        <p:grpSpPr>
          <a:xfrm>
            <a:off x="957240" y="365040"/>
            <a:ext cx="3809880" cy="6010560"/>
            <a:chOff x="957240" y="365040"/>
            <a:chExt cx="3809880" cy="6010560"/>
          </a:xfrm>
        </p:grpSpPr>
        <p:grpSp>
          <p:nvGrpSpPr>
            <p:cNvPr id="42" name="그룹 8"/>
            <p:cNvGrpSpPr/>
            <p:nvPr/>
          </p:nvGrpSpPr>
          <p:grpSpPr>
            <a:xfrm>
              <a:off x="957240" y="365040"/>
              <a:ext cx="3809880" cy="5817240"/>
              <a:chOff x="957240" y="365040"/>
              <a:chExt cx="3809880" cy="5817240"/>
            </a:xfrm>
          </p:grpSpPr>
          <p:pic>
            <p:nvPicPr>
              <p:cNvPr id="43" name="Picture 7" descr=""/>
              <p:cNvPicPr/>
              <p:nvPr/>
            </p:nvPicPr>
            <p:blipFill>
              <a:blip r:embed="rId1"/>
              <a:srcRect l="0" t="7267" r="19294" b="0"/>
              <a:stretch/>
            </p:blipFill>
            <p:spPr>
              <a:xfrm>
                <a:off x="957240" y="365040"/>
                <a:ext cx="3809880" cy="595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8" descr=""/>
              <p:cNvPicPr/>
              <p:nvPr/>
            </p:nvPicPr>
            <p:blipFill>
              <a:blip r:embed="rId2"/>
              <a:srcRect l="0" t="0" r="19344" b="443"/>
              <a:stretch/>
            </p:blipFill>
            <p:spPr>
              <a:xfrm>
                <a:off x="965160" y="936000"/>
                <a:ext cx="3797640" cy="52462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5" name="직사각형 14"/>
            <p:cNvSpPr/>
            <p:nvPr/>
          </p:nvSpPr>
          <p:spPr>
            <a:xfrm>
              <a:off x="1685880" y="852120"/>
              <a:ext cx="92556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직사각형 15"/>
            <p:cNvSpPr/>
            <p:nvPr/>
          </p:nvSpPr>
          <p:spPr>
            <a:xfrm>
              <a:off x="2628720" y="852120"/>
              <a:ext cx="124920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직사각형 16"/>
            <p:cNvSpPr/>
            <p:nvPr/>
          </p:nvSpPr>
          <p:spPr>
            <a:xfrm>
              <a:off x="4049640" y="850680"/>
              <a:ext cx="29844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직사각형 17"/>
            <p:cNvSpPr/>
            <p:nvPr/>
          </p:nvSpPr>
          <p:spPr>
            <a:xfrm>
              <a:off x="4519800" y="852120"/>
              <a:ext cx="14580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직사각형 18"/>
            <p:cNvSpPr/>
            <p:nvPr/>
          </p:nvSpPr>
          <p:spPr>
            <a:xfrm>
              <a:off x="3895560" y="852120"/>
              <a:ext cx="14256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직사각형 19"/>
            <p:cNvSpPr/>
            <p:nvPr/>
          </p:nvSpPr>
          <p:spPr>
            <a:xfrm>
              <a:off x="4365720" y="852120"/>
              <a:ext cx="139680" cy="526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TextBox 20"/>
            <p:cNvSpPr/>
            <p:nvPr/>
          </p:nvSpPr>
          <p:spPr>
            <a:xfrm>
              <a:off x="2034000" y="612936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TextBox 21"/>
            <p:cNvSpPr/>
            <p:nvPr/>
          </p:nvSpPr>
          <p:spPr>
            <a:xfrm>
              <a:off x="3120840" y="612936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II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TextBox 22"/>
            <p:cNvSpPr/>
            <p:nvPr/>
          </p:nvSpPr>
          <p:spPr>
            <a:xfrm>
              <a:off x="3803760" y="612936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III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TextBox 23"/>
            <p:cNvSpPr/>
            <p:nvPr/>
          </p:nvSpPr>
          <p:spPr>
            <a:xfrm>
              <a:off x="4038120" y="61293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IV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TextBox 24"/>
            <p:cNvSpPr/>
            <p:nvPr/>
          </p:nvSpPr>
          <p:spPr>
            <a:xfrm>
              <a:off x="4299120" y="612936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V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TextBox 25"/>
            <p:cNvSpPr/>
            <p:nvPr/>
          </p:nvSpPr>
          <p:spPr>
            <a:xfrm>
              <a:off x="4431240" y="61293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VI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7" name="Text Box 19"/>
          <p:cNvSpPr/>
          <p:nvPr/>
        </p:nvSpPr>
        <p:spPr>
          <a:xfrm>
            <a:off x="5156280" y="289080"/>
            <a:ext cx="37242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ure S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he clone order fingerprints of 19 of 22 positive BAC clones for the BAN2 marker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The clone order is the same as in Figure 3A. The number on the clone name indicates the contig number. ‘0’ indicates a singleton.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직사각형 26"/>
          <p:cNvSpPr/>
          <p:nvPr/>
        </p:nvSpPr>
        <p:spPr>
          <a:xfrm>
            <a:off x="884160" y="289080"/>
            <a:ext cx="3943440" cy="61704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04T04:50:53Z</dcterms:created>
  <dc:creator>J.-H. Mun</dc:creator>
  <dc:description/>
  <dc:language>en-US</dc:language>
  <cp:lastModifiedBy>J.-H. Mun</cp:lastModifiedBy>
  <dcterms:modified xsi:type="dcterms:W3CDTF">2008-06-04T07:50:31Z</dcterms:modified>
  <cp:revision>2</cp:revision>
  <dc:subject/>
  <dc:title>슬라이드 1</dc:title>
</cp:coreProperties>
</file>